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600" r:id="rId2"/>
  </p:sldIdLst>
  <p:sldSz cx="12192000" cy="6858000"/>
  <p:notesSz cx="12192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840" userDrawn="1">
          <p15:clr>
            <a:srgbClr val="A4A3A4"/>
          </p15:clr>
        </p15:guide>
        <p15:guide id="3" orient="horz" pos="124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ulie O'Neal" initials="JO" lastIdx="3" clrIdx="0"/>
  <p:cmAuthor id="2" name="Zachary Crees" initials="ZDC" lastIdx="19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9EDF5"/>
    <a:srgbClr val="CFD9E7"/>
    <a:srgbClr val="4F81BD"/>
    <a:srgbClr val="FEFEFE"/>
    <a:srgbClr val="D0D9E9"/>
    <a:srgbClr val="FCFFA4"/>
    <a:srgbClr val="4F81BE"/>
    <a:srgbClr val="FB9301"/>
    <a:srgbClr val="2866AD"/>
    <a:srgbClr val="2966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266"/>
    <p:restoredTop sz="97030"/>
  </p:normalViewPr>
  <p:slideViewPr>
    <p:cSldViewPr>
      <p:cViewPr varScale="1">
        <p:scale>
          <a:sx n="143" d="100"/>
          <a:sy n="143" d="100"/>
        </p:scale>
        <p:origin x="1248" y="208"/>
      </p:cViewPr>
      <p:guideLst>
        <p:guide pos="3840"/>
        <p:guide orient="horz" pos="124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473AAB49-AA4F-E840-91E1-7F8A00EC403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52832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18D17C-B95A-C84B-B471-7700FCB52EB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6905625" y="0"/>
            <a:ext cx="52832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42E53B-17CC-2643-93A9-C1AE615DE5C1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AFAD70-C47B-0443-ACB0-1860F7A173A5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6513513"/>
            <a:ext cx="52832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3E68509-07E1-CD43-90E4-BA71233BF4E1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6905625" y="6513513"/>
            <a:ext cx="52832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CD11F9-4AB1-EE48-93A4-737222A8B2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0488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186212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2125980"/>
            <a:ext cx="10363200" cy="144017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3840480"/>
            <a:ext cx="8534399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r>
              <a:rPr lang="en-US"/>
              <a:t>Click to edit Master subtitle style</a:t>
            </a:r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AACE3-115E-3947-B947-DED9F41CEAF4}" type="datetime1">
              <a:rPr lang="en-US" smtClean="0"/>
              <a:t>10/24/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34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 b="0" i="0">
                <a:solidFill>
                  <a:schemeClr val="tx1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68C93D-8B65-C543-8EC1-851AFFC59229}" type="datetime1">
              <a:rPr lang="en-US" smtClean="0"/>
              <a:t>10/24/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57200" y="6581001"/>
            <a:ext cx="2804160" cy="276999"/>
          </a:xfrm>
        </p:spPr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34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1306173" y="1989338"/>
            <a:ext cx="3451860" cy="427101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24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79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22499-75CB-8C41-9C5B-2B900FE5AFCB}" type="datetime1">
              <a:rPr lang="en-US" smtClean="0"/>
              <a:t>10/24/25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Only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34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r>
              <a:rPr lang="en-US"/>
              <a:t>Click to edit Master title style</a:t>
            </a:r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1BCB95-6B61-1248-80BD-2B9A2417F1DD}" type="datetime1">
              <a:rPr lang="en-US" smtClean="0"/>
              <a:t>10/24/25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F70362-40D7-3B47-9D19-71A33914F997}" type="datetime1">
              <a:rPr lang="en-US" smtClean="0"/>
              <a:t>10/24/25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0" y="0"/>
            <a:ext cx="12191999" cy="365759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k object 17"/>
          <p:cNvSpPr/>
          <p:nvPr/>
        </p:nvSpPr>
        <p:spPr>
          <a:xfrm>
            <a:off x="0" y="0"/>
            <a:ext cx="3785870" cy="355600"/>
          </a:xfrm>
          <a:custGeom>
            <a:avLst/>
            <a:gdLst/>
            <a:ahLst/>
            <a:cxnLst/>
            <a:rect l="l" t="t" r="r" b="b"/>
            <a:pathLst>
              <a:path w="3785870" h="355600">
                <a:moveTo>
                  <a:pt x="3529279" y="0"/>
                </a:moveTo>
                <a:lnTo>
                  <a:pt x="0" y="0"/>
                </a:lnTo>
                <a:lnTo>
                  <a:pt x="0" y="352463"/>
                </a:lnTo>
                <a:lnTo>
                  <a:pt x="3785616" y="355092"/>
                </a:lnTo>
                <a:lnTo>
                  <a:pt x="3529279" y="0"/>
                </a:lnTo>
                <a:close/>
              </a:path>
            </a:pathLst>
          </a:custGeom>
          <a:solidFill>
            <a:srgbClr val="0066B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bk object 18"/>
          <p:cNvSpPr/>
          <p:nvPr/>
        </p:nvSpPr>
        <p:spPr>
          <a:xfrm>
            <a:off x="0" y="0"/>
            <a:ext cx="3785870" cy="355600"/>
          </a:xfrm>
          <a:custGeom>
            <a:avLst/>
            <a:gdLst/>
            <a:ahLst/>
            <a:cxnLst/>
            <a:rect l="l" t="t" r="r" b="b"/>
            <a:pathLst>
              <a:path w="3785870" h="355600">
                <a:moveTo>
                  <a:pt x="3529287" y="1524"/>
                </a:moveTo>
                <a:lnTo>
                  <a:pt x="3785616" y="356616"/>
                </a:lnTo>
                <a:lnTo>
                  <a:pt x="0" y="353999"/>
                </a:lnTo>
                <a:lnTo>
                  <a:pt x="0" y="1524"/>
                </a:lnTo>
              </a:path>
            </a:pathLst>
          </a:custGeom>
          <a:ln w="12192">
            <a:solidFill>
              <a:srgbClr val="0066B3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520694" y="722816"/>
            <a:ext cx="11150610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3400" b="0" i="0">
                <a:solidFill>
                  <a:schemeClr val="tx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54133" y="1639630"/>
            <a:ext cx="10883732" cy="44704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b="0" i="0">
                <a:solidFill>
                  <a:schemeClr val="tx1"/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377940"/>
            <a:ext cx="3901439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17E37-B94F-0E40-B5CB-E7392F3114CB}" type="datetime1">
              <a:rPr lang="en-US" smtClean="0"/>
              <a:t>10/24/25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57200" y="6581001"/>
            <a:ext cx="2804160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hf hdr="0" ftr="0" dt="0"/>
  <p:txStyles>
    <p:titleStyle>
      <a:lvl1pPr eaLnBrk="1" hangingPunct="1">
        <a:defRPr>
          <a:latin typeface="+mj-lt"/>
          <a:ea typeface="+mj-ea"/>
          <a:cs typeface="+mj-cs"/>
        </a:defRPr>
      </a:lvl1pPr>
    </p:titleStyle>
    <p:bodyStyle>
      <a:lvl1pPr marL="0" eaLnBrk="1" hangingPunct="1">
        <a:defRPr>
          <a:latin typeface="+mn-lt"/>
          <a:ea typeface="+mn-ea"/>
          <a:cs typeface="+mn-cs"/>
        </a:defRPr>
      </a:lvl1pPr>
      <a:lvl2pPr marL="457200" eaLnBrk="1" hangingPunct="1">
        <a:defRPr>
          <a:latin typeface="+mn-lt"/>
          <a:ea typeface="+mn-ea"/>
          <a:cs typeface="+mn-cs"/>
        </a:defRPr>
      </a:lvl2pPr>
      <a:lvl3pPr marL="914400" eaLnBrk="1" hangingPunct="1">
        <a:defRPr>
          <a:latin typeface="+mn-lt"/>
          <a:ea typeface="+mn-ea"/>
          <a:cs typeface="+mn-cs"/>
        </a:defRPr>
      </a:lvl3pPr>
      <a:lvl4pPr marL="1371600" eaLnBrk="1" hangingPunct="1">
        <a:defRPr>
          <a:latin typeface="+mn-lt"/>
          <a:ea typeface="+mn-ea"/>
          <a:cs typeface="+mn-cs"/>
        </a:defRPr>
      </a:lvl4pPr>
      <a:lvl5pPr marL="1828800" eaLnBrk="1" hangingPunct="1">
        <a:defRPr>
          <a:latin typeface="+mn-lt"/>
          <a:ea typeface="+mn-ea"/>
          <a:cs typeface="+mn-cs"/>
        </a:defRPr>
      </a:lvl5pPr>
      <a:lvl6pPr marL="2286000" eaLnBrk="1" hangingPunct="1">
        <a:defRPr>
          <a:latin typeface="+mn-lt"/>
          <a:ea typeface="+mn-ea"/>
          <a:cs typeface="+mn-cs"/>
        </a:defRPr>
      </a:lvl6pPr>
      <a:lvl7pPr marL="2743200" eaLnBrk="1" hangingPunct="1">
        <a:defRPr>
          <a:latin typeface="+mn-lt"/>
          <a:ea typeface="+mn-ea"/>
          <a:cs typeface="+mn-cs"/>
        </a:defRPr>
      </a:lvl7pPr>
      <a:lvl8pPr marL="3200400" eaLnBrk="1" hangingPunct="1">
        <a:defRPr>
          <a:latin typeface="+mn-lt"/>
          <a:ea typeface="+mn-ea"/>
          <a:cs typeface="+mn-cs"/>
        </a:defRPr>
      </a:lvl8pPr>
      <a:lvl9pPr marL="3657600" eaLnBrk="1" hangingPunct="1">
        <a:defRPr>
          <a:latin typeface="+mn-lt"/>
          <a:ea typeface="+mn-ea"/>
          <a:cs typeface="+mn-cs"/>
        </a:defRPr>
      </a:lvl9pPr>
    </p:bodyStyle>
    <p:otherStyle>
      <a:lvl1pPr marL="0" eaLnBrk="1" hangingPunct="1">
        <a:defRPr>
          <a:latin typeface="+mn-lt"/>
          <a:ea typeface="+mn-ea"/>
          <a:cs typeface="+mn-cs"/>
        </a:defRPr>
      </a:lvl1pPr>
      <a:lvl2pPr marL="457200" eaLnBrk="1" hangingPunct="1">
        <a:defRPr>
          <a:latin typeface="+mn-lt"/>
          <a:ea typeface="+mn-ea"/>
          <a:cs typeface="+mn-cs"/>
        </a:defRPr>
      </a:lvl2pPr>
      <a:lvl3pPr marL="914400" eaLnBrk="1" hangingPunct="1">
        <a:defRPr>
          <a:latin typeface="+mn-lt"/>
          <a:ea typeface="+mn-ea"/>
          <a:cs typeface="+mn-cs"/>
        </a:defRPr>
      </a:lvl3pPr>
      <a:lvl4pPr marL="1371600" eaLnBrk="1" hangingPunct="1">
        <a:defRPr>
          <a:latin typeface="+mn-lt"/>
          <a:ea typeface="+mn-ea"/>
          <a:cs typeface="+mn-cs"/>
        </a:defRPr>
      </a:lvl4pPr>
      <a:lvl5pPr marL="1828800" eaLnBrk="1" hangingPunct="1">
        <a:defRPr>
          <a:latin typeface="+mn-lt"/>
          <a:ea typeface="+mn-ea"/>
          <a:cs typeface="+mn-cs"/>
        </a:defRPr>
      </a:lvl5pPr>
      <a:lvl6pPr marL="2286000" eaLnBrk="1" hangingPunct="1">
        <a:defRPr>
          <a:latin typeface="+mn-lt"/>
          <a:ea typeface="+mn-ea"/>
          <a:cs typeface="+mn-cs"/>
        </a:defRPr>
      </a:lvl6pPr>
      <a:lvl7pPr marL="2743200" eaLnBrk="1" hangingPunct="1">
        <a:defRPr>
          <a:latin typeface="+mn-lt"/>
          <a:ea typeface="+mn-ea"/>
          <a:cs typeface="+mn-cs"/>
        </a:defRPr>
      </a:lvl7pPr>
      <a:lvl8pPr marL="3200400" eaLnBrk="1" hangingPunct="1">
        <a:defRPr>
          <a:latin typeface="+mn-lt"/>
          <a:ea typeface="+mn-ea"/>
          <a:cs typeface="+mn-cs"/>
        </a:defRPr>
      </a:lvl8pPr>
      <a:lvl9pPr marL="3657600" eaLnBrk="1" hangingPunct="1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7">
            <a:extLst>
              <a:ext uri="{FF2B5EF4-FFF2-40B4-BE49-F238E27FC236}">
                <a16:creationId xmlns:a16="http://schemas.microsoft.com/office/drawing/2014/main" id="{40D21520-226A-28A7-796C-55944A2F24F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5615227"/>
              </p:ext>
            </p:extLst>
          </p:nvPr>
        </p:nvGraphicFramePr>
        <p:xfrm>
          <a:off x="2743200" y="1280160"/>
          <a:ext cx="6198391" cy="4968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47800">
                  <a:extLst>
                    <a:ext uri="{9D8B030D-6E8A-4147-A177-3AD203B41FA5}">
                      <a16:colId xmlns:a16="http://schemas.microsoft.com/office/drawing/2014/main" val="3680387567"/>
                    </a:ext>
                  </a:extLst>
                </a:gridCol>
                <a:gridCol w="1371600">
                  <a:extLst>
                    <a:ext uri="{9D8B030D-6E8A-4147-A177-3AD203B41FA5}">
                      <a16:colId xmlns:a16="http://schemas.microsoft.com/office/drawing/2014/main" val="3208508706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val="1605828236"/>
                    </a:ext>
                  </a:extLst>
                </a:gridCol>
                <a:gridCol w="1400977">
                  <a:extLst>
                    <a:ext uri="{9D8B030D-6E8A-4147-A177-3AD203B41FA5}">
                      <a16:colId xmlns:a16="http://schemas.microsoft.com/office/drawing/2014/main" val="85791091"/>
                    </a:ext>
                  </a:extLst>
                </a:gridCol>
                <a:gridCol w="911214">
                  <a:extLst>
                    <a:ext uri="{9D8B030D-6E8A-4147-A177-3AD203B41FA5}">
                      <a16:colId xmlns:a16="http://schemas.microsoft.com/office/drawing/2014/main" val="390688651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atego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Variab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Upro, 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Placebo, 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P-valu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750853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edian Ag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Year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65.5 year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64.5 year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.3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8388871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Sex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a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9 (35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0 (42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.6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499906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Fema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7 (65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4 (58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8492951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Rac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Whit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26 (10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22 (92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.8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7766721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Black or African America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 (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2 (8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8162220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R-ISS Stag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6 (23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7 (29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.6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103851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I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6 (23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8 (33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735206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II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1 (42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6 (25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6858931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Unknow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3 (12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3 (13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014645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MWG Respons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6 (23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6 (25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0.1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48274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VGPR*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2 (46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16 (67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387452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P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8 (31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2 (8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-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395968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157073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v11 HSC Mobilization and GENESIS Trial Results" id="{6E4E2C5B-3961-1D4F-8FC4-2B1D138CA031}" vid="{8429A75F-8FD2-B14C-9100-6FF05D74B434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797</TotalTime>
  <Words>146</Words>
  <Application>Microsoft Macintosh PowerPoint</Application>
  <PresentationFormat>Widescreen</PresentationFormat>
  <Paragraphs>6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novations in Hematopoietic Stem Cell Mobilization: The GENESIS Trial - CXCR4 Inhibition with Motixafortide (BL-8040) + G-CSF for HSC Mobilization in Multiple Myeloma</dc:title>
  <dc:subject/>
  <dc:creator>Zachary Crees</dc:creator>
  <cp:keywords/>
  <dc:description/>
  <cp:lastModifiedBy>Crees, Zachary</cp:lastModifiedBy>
  <cp:revision>244</cp:revision>
  <cp:lastPrinted>2019-08-06T16:23:38Z</cp:lastPrinted>
  <dcterms:created xsi:type="dcterms:W3CDTF">2021-05-27T13:49:15Z</dcterms:created>
  <dcterms:modified xsi:type="dcterms:W3CDTF">2025-10-24T05:10:28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9-06-05T10:00:00Z</vt:filetime>
  </property>
  <property fmtid="{D5CDD505-2E9C-101B-9397-08002B2CF9AE}" pid="3" name="LastSaved">
    <vt:filetime>2019-06-20T10:00:00Z</vt:filetime>
  </property>
</Properties>
</file>